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7" r:id="rId2"/>
    <p:sldId id="283" r:id="rId3"/>
  </p:sldIdLst>
  <p:sldSz cx="6675438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FF20"/>
    <a:srgbClr val="912FE7"/>
    <a:srgbClr val="FF7E79"/>
    <a:srgbClr val="009193"/>
    <a:srgbClr val="FF22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27D3937-3DCD-4963-B91D-186384807C73}" v="13" dt="2023-07-29T00:11:31.98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69"/>
    <p:restoredTop sz="93878"/>
  </p:normalViewPr>
  <p:slideViewPr>
    <p:cSldViewPr>
      <p:cViewPr varScale="1">
        <p:scale>
          <a:sx n="79" d="100"/>
          <a:sy n="79" d="100"/>
        </p:scale>
        <p:origin x="401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38100" cy="3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bdiaz\Desktop\H460%20xenograft%20data\Exp2-H460%20Xenograft%20Repeat%20Study%20Subcutaneous%20Administration%20copyBD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bdiaz\Desktop\H460%20xenograft%20data\Exp2-H460%20Xenograft%20Repeat%20Study%20Subcutaneous%20Administration%20copyBD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bdiaz\Desktop\H460%20xenograft%20data\Exp2-H460%20Xenograft%20Repeat%20Study%20Subcutaneous%20Administration%20copyBD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Tumor Volume Analysis (paper)'!$O$2</c:f>
              <c:strCache>
                <c:ptCount val="1"/>
                <c:pt idx="0">
                  <c:v>1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O$3:$O$17</c:f>
              <c:numCache>
                <c:formatCode>General</c:formatCode>
                <c:ptCount val="15"/>
                <c:pt idx="0">
                  <c:v>18</c:v>
                </c:pt>
                <c:pt idx="1">
                  <c:v>19.968000000000004</c:v>
                </c:pt>
                <c:pt idx="2">
                  <c:v>26.567999999999998</c:v>
                </c:pt>
                <c:pt idx="3">
                  <c:v>29.808</c:v>
                </c:pt>
                <c:pt idx="4">
                  <c:v>31.752000000000006</c:v>
                </c:pt>
                <c:pt idx="5">
                  <c:v>44</c:v>
                </c:pt>
                <c:pt idx="6">
                  <c:v>47.067999999999991</c:v>
                </c:pt>
                <c:pt idx="7">
                  <c:v>52.6965</c:v>
                </c:pt>
                <c:pt idx="8">
                  <c:v>58.725000000000001</c:v>
                </c:pt>
                <c:pt idx="9">
                  <c:v>75.631500000000017</c:v>
                </c:pt>
                <c:pt idx="10">
                  <c:v>112.36</c:v>
                </c:pt>
                <c:pt idx="11">
                  <c:v>129.96</c:v>
                </c:pt>
                <c:pt idx="12">
                  <c:v>131.58449999999999</c:v>
                </c:pt>
                <c:pt idx="13">
                  <c:v>137.92399999999998</c:v>
                </c:pt>
                <c:pt idx="14">
                  <c:v>141.288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A4-064A-BA5F-8D45ECB4111F}"/>
            </c:ext>
          </c:extLst>
        </c:ser>
        <c:ser>
          <c:idx val="1"/>
          <c:order val="1"/>
          <c:tx>
            <c:strRef>
              <c:f>'Tumor Volume Analysis (paper)'!$P$2</c:f>
              <c:strCache>
                <c:ptCount val="1"/>
                <c:pt idx="0">
                  <c:v>2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P$3:$P$17</c:f>
              <c:numCache>
                <c:formatCode>General</c:formatCode>
                <c:ptCount val="15"/>
                <c:pt idx="0">
                  <c:v>27.380000000000003</c:v>
                </c:pt>
                <c:pt idx="1">
                  <c:v>39.503499999999995</c:v>
                </c:pt>
                <c:pt idx="2">
                  <c:v>44.981999999999999</c:v>
                </c:pt>
                <c:pt idx="3">
                  <c:v>50.274000000000001</c:v>
                </c:pt>
                <c:pt idx="4">
                  <c:v>54.545499999999997</c:v>
                </c:pt>
                <c:pt idx="5">
                  <c:v>116.27200000000001</c:v>
                </c:pt>
                <c:pt idx="6">
                  <c:v>142.17500000000001</c:v>
                </c:pt>
                <c:pt idx="7">
                  <c:v>154.32750000000001</c:v>
                </c:pt>
                <c:pt idx="8">
                  <c:v>174.6</c:v>
                </c:pt>
                <c:pt idx="9">
                  <c:v>206.84800000000004</c:v>
                </c:pt>
                <c:pt idx="10">
                  <c:v>485.51400000000001</c:v>
                </c:pt>
                <c:pt idx="11">
                  <c:v>492.07499999999999</c:v>
                </c:pt>
                <c:pt idx="12">
                  <c:v>554.56450000000018</c:v>
                </c:pt>
                <c:pt idx="13">
                  <c:v>582.12</c:v>
                </c:pt>
                <c:pt idx="14">
                  <c:v>639.580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8A4-064A-BA5F-8D45ECB4111F}"/>
            </c:ext>
          </c:extLst>
        </c:ser>
        <c:ser>
          <c:idx val="2"/>
          <c:order val="2"/>
          <c:tx>
            <c:strRef>
              <c:f>'Tumor Volume Analysis (paper)'!$Q$2</c:f>
              <c:strCache>
                <c:ptCount val="1"/>
                <c:pt idx="0">
                  <c:v>3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Q$3:$Q$17</c:f>
              <c:numCache>
                <c:formatCode>General</c:formatCode>
                <c:ptCount val="15"/>
                <c:pt idx="0">
                  <c:v>60.75</c:v>
                </c:pt>
                <c:pt idx="1">
                  <c:v>103.93300000000001</c:v>
                </c:pt>
                <c:pt idx="2">
                  <c:v>135</c:v>
                </c:pt>
                <c:pt idx="3">
                  <c:v>147.99400000000003</c:v>
                </c:pt>
                <c:pt idx="4">
                  <c:v>161.79200000000003</c:v>
                </c:pt>
                <c:pt idx="5">
                  <c:v>276.82199999999995</c:v>
                </c:pt>
                <c:pt idx="6">
                  <c:v>356.32799999999997</c:v>
                </c:pt>
                <c:pt idx="7">
                  <c:v>388.28999999999996</c:v>
                </c:pt>
                <c:pt idx="8">
                  <c:v>433.34999999999997</c:v>
                </c:pt>
                <c:pt idx="9">
                  <c:v>518.9375</c:v>
                </c:pt>
                <c:pt idx="10">
                  <c:v>761.35849999999994</c:v>
                </c:pt>
                <c:pt idx="11">
                  <c:v>925.75</c:v>
                </c:pt>
                <c:pt idx="12">
                  <c:v>1036.8</c:v>
                </c:pt>
                <c:pt idx="13">
                  <c:v>1127.1105000000002</c:v>
                </c:pt>
                <c:pt idx="14">
                  <c:v>1164.0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8A4-064A-BA5F-8D45ECB4111F}"/>
            </c:ext>
          </c:extLst>
        </c:ser>
        <c:ser>
          <c:idx val="3"/>
          <c:order val="3"/>
          <c:tx>
            <c:strRef>
              <c:f>'Tumor Volume Analysis (paper)'!$R$2</c:f>
              <c:strCache>
                <c:ptCount val="1"/>
                <c:pt idx="0">
                  <c:v>4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R$3:$R$17</c:f>
              <c:numCache>
                <c:formatCode>General</c:formatCode>
                <c:ptCount val="15"/>
                <c:pt idx="0">
                  <c:v>92.512</c:v>
                </c:pt>
                <c:pt idx="1">
                  <c:v>106.1705</c:v>
                </c:pt>
                <c:pt idx="2">
                  <c:v>144.86849999999998</c:v>
                </c:pt>
                <c:pt idx="3">
                  <c:v>158.4375</c:v>
                </c:pt>
                <c:pt idx="4">
                  <c:v>236.25</c:v>
                </c:pt>
                <c:pt idx="5">
                  <c:v>433.34999999999997</c:v>
                </c:pt>
                <c:pt idx="6">
                  <c:v>437.40000000000003</c:v>
                </c:pt>
                <c:pt idx="7">
                  <c:v>575</c:v>
                </c:pt>
                <c:pt idx="8">
                  <c:v>636.54000000000008</c:v>
                </c:pt>
                <c:pt idx="9">
                  <c:v>716.625</c:v>
                </c:pt>
                <c:pt idx="10">
                  <c:v>1350.36</c:v>
                </c:pt>
                <c:pt idx="11">
                  <c:v>1461.184</c:v>
                </c:pt>
                <c:pt idx="12">
                  <c:v>1548.4</c:v>
                </c:pt>
                <c:pt idx="13">
                  <c:v>1669.2480000000003</c:v>
                </c:pt>
                <c:pt idx="14">
                  <c:v>1807.08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8A4-064A-BA5F-8D45ECB4111F}"/>
            </c:ext>
          </c:extLst>
        </c:ser>
        <c:ser>
          <c:idx val="4"/>
          <c:order val="4"/>
          <c:tx>
            <c:strRef>
              <c:f>'Tumor Volume Analysis (paper)'!$S$2</c:f>
              <c:strCache>
                <c:ptCount val="1"/>
                <c:pt idx="0">
                  <c:v>5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S$3:$S$17</c:f>
              <c:numCache>
                <c:formatCode>General</c:formatCode>
                <c:ptCount val="15"/>
                <c:pt idx="0">
                  <c:v>105.84</c:v>
                </c:pt>
                <c:pt idx="1">
                  <c:v>116.16000000000003</c:v>
                </c:pt>
                <c:pt idx="2">
                  <c:v>153.21600000000001</c:v>
                </c:pt>
                <c:pt idx="3">
                  <c:v>217.8</c:v>
                </c:pt>
                <c:pt idx="4">
                  <c:v>268.04250000000002</c:v>
                </c:pt>
                <c:pt idx="5">
                  <c:v>446.48999999999995</c:v>
                </c:pt>
                <c:pt idx="6">
                  <c:v>514.5</c:v>
                </c:pt>
                <c:pt idx="7">
                  <c:v>546.91200000000003</c:v>
                </c:pt>
                <c:pt idx="8">
                  <c:v>630</c:v>
                </c:pt>
                <c:pt idx="9">
                  <c:v>756.44999999999993</c:v>
                </c:pt>
                <c:pt idx="10">
                  <c:v>1082.4100000000001</c:v>
                </c:pt>
                <c:pt idx="11">
                  <c:v>1152</c:v>
                </c:pt>
                <c:pt idx="12">
                  <c:v>1275</c:v>
                </c:pt>
                <c:pt idx="13">
                  <c:v>1352.6475000000003</c:v>
                </c:pt>
                <c:pt idx="14">
                  <c:v>1476.920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8A4-064A-BA5F-8D45ECB4111F}"/>
            </c:ext>
          </c:extLst>
        </c:ser>
        <c:ser>
          <c:idx val="5"/>
          <c:order val="5"/>
          <c:tx>
            <c:strRef>
              <c:f>'Tumor Volume Analysis (paper)'!$T$2</c:f>
              <c:strCache>
                <c:ptCount val="1"/>
                <c:pt idx="0">
                  <c:v>6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T$3:$T$17</c:f>
              <c:numCache>
                <c:formatCode>General</c:formatCode>
                <c:ptCount val="15"/>
                <c:pt idx="0">
                  <c:v>162</c:v>
                </c:pt>
                <c:pt idx="1">
                  <c:v>219.006</c:v>
                </c:pt>
                <c:pt idx="2">
                  <c:v>273.8</c:v>
                </c:pt>
                <c:pt idx="3">
                  <c:v>281.25</c:v>
                </c:pt>
                <c:pt idx="4">
                  <c:v>334.62</c:v>
                </c:pt>
                <c:pt idx="5">
                  <c:v>671.05799999999999</c:v>
                </c:pt>
                <c:pt idx="6">
                  <c:v>781.48800000000017</c:v>
                </c:pt>
                <c:pt idx="7">
                  <c:v>1044</c:v>
                </c:pt>
                <c:pt idx="8">
                  <c:v>1209.675</c:v>
                </c:pt>
                <c:pt idx="9">
                  <c:v>1403.325</c:v>
                </c:pt>
                <c:pt idx="10">
                  <c:v>2096.9760000000001</c:v>
                </c:pt>
                <c:pt idx="11">
                  <c:v>2528.75</c:v>
                </c:pt>
                <c:pt idx="12">
                  <c:v>2899.0860000000002</c:v>
                </c:pt>
                <c:pt idx="13">
                  <c:v>2930.7700000000004</c:v>
                </c:pt>
                <c:pt idx="14">
                  <c:v>3027.8744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D8A4-064A-BA5F-8D45ECB4111F}"/>
            </c:ext>
          </c:extLst>
        </c:ser>
        <c:ser>
          <c:idx val="6"/>
          <c:order val="6"/>
          <c:tx>
            <c:strRef>
              <c:f>'Tumor Volume Analysis (paper)'!$U$2</c:f>
              <c:strCache>
                <c:ptCount val="1"/>
                <c:pt idx="0">
                  <c:v>7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U$3:$U$17</c:f>
              <c:numCache>
                <c:formatCode>General</c:formatCode>
                <c:ptCount val="15"/>
                <c:pt idx="0">
                  <c:v>189.48599999999996</c:v>
                </c:pt>
                <c:pt idx="1">
                  <c:v>215.01599999999999</c:v>
                </c:pt>
                <c:pt idx="2">
                  <c:v>265.58600000000001</c:v>
                </c:pt>
                <c:pt idx="3">
                  <c:v>284.0625</c:v>
                </c:pt>
                <c:pt idx="4">
                  <c:v>317.20150000000001</c:v>
                </c:pt>
                <c:pt idx="5">
                  <c:v>591.29999999999995</c:v>
                </c:pt>
                <c:pt idx="6">
                  <c:v>630.56799999999987</c:v>
                </c:pt>
                <c:pt idx="7">
                  <c:v>723.4559999999999</c:v>
                </c:pt>
                <c:pt idx="8">
                  <c:v>884.33999999999992</c:v>
                </c:pt>
                <c:pt idx="9">
                  <c:v>942.63750000000005</c:v>
                </c:pt>
                <c:pt idx="10">
                  <c:v>1256.375</c:v>
                </c:pt>
                <c:pt idx="11">
                  <c:v>1425.6000000000001</c:v>
                </c:pt>
                <c:pt idx="12">
                  <c:v>1520.4645000000003</c:v>
                </c:pt>
                <c:pt idx="13">
                  <c:v>1570.3125</c:v>
                </c:pt>
                <c:pt idx="14">
                  <c:v>1611.41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D8A4-064A-BA5F-8D45ECB4111F}"/>
            </c:ext>
          </c:extLst>
        </c:ser>
        <c:ser>
          <c:idx val="7"/>
          <c:order val="7"/>
          <c:tx>
            <c:strRef>
              <c:f>'Tumor Volume Analysis (paper)'!$V$2</c:f>
              <c:strCache>
                <c:ptCount val="1"/>
                <c:pt idx="0">
                  <c:v>8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V$3:$V$17</c:f>
              <c:numCache>
                <c:formatCode>General</c:formatCode>
                <c:ptCount val="15"/>
                <c:pt idx="0">
                  <c:v>268.363</c:v>
                </c:pt>
                <c:pt idx="1">
                  <c:v>294.39999999999998</c:v>
                </c:pt>
                <c:pt idx="2">
                  <c:v>322.75199999999995</c:v>
                </c:pt>
                <c:pt idx="3">
                  <c:v>383.32800000000009</c:v>
                </c:pt>
                <c:pt idx="4">
                  <c:v>430.61199999999997</c:v>
                </c:pt>
                <c:pt idx="5">
                  <c:v>915.0625</c:v>
                </c:pt>
                <c:pt idx="6">
                  <c:v>937.024</c:v>
                </c:pt>
                <c:pt idx="7">
                  <c:v>1239.3</c:v>
                </c:pt>
                <c:pt idx="8">
                  <c:v>1391.6</c:v>
                </c:pt>
                <c:pt idx="9">
                  <c:v>1598.7</c:v>
                </c:pt>
                <c:pt idx="10">
                  <c:v>2756.8640000000005</c:v>
                </c:pt>
                <c:pt idx="11">
                  <c:v>2819.6099999999997</c:v>
                </c:pt>
                <c:pt idx="12">
                  <c:v>2851.5600000000004</c:v>
                </c:pt>
                <c:pt idx="13">
                  <c:v>3047.4079999999994</c:v>
                </c:pt>
                <c:pt idx="14">
                  <c:v>3114.47700000000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D8A4-064A-BA5F-8D45ECB4111F}"/>
            </c:ext>
          </c:extLst>
        </c:ser>
        <c:ser>
          <c:idx val="8"/>
          <c:order val="8"/>
          <c:tx>
            <c:strRef>
              <c:f>'Tumor Volume Analysis (paper)'!$W$2</c:f>
              <c:strCache>
                <c:ptCount val="1"/>
                <c:pt idx="0">
                  <c:v>9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:$N$1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W$3:$W$17</c:f>
              <c:numCache>
                <c:formatCode>General</c:formatCode>
                <c:ptCount val="15"/>
                <c:pt idx="0">
                  <c:v>346.79999999999995</c:v>
                </c:pt>
                <c:pt idx="1">
                  <c:v>357.07500000000005</c:v>
                </c:pt>
                <c:pt idx="2">
                  <c:v>396.57600000000002</c:v>
                </c:pt>
                <c:pt idx="3">
                  <c:v>465.46000000000004</c:v>
                </c:pt>
                <c:pt idx="4">
                  <c:v>546.08749999999998</c:v>
                </c:pt>
                <c:pt idx="5">
                  <c:v>843.83800000000019</c:v>
                </c:pt>
                <c:pt idx="6">
                  <c:v>931.49099999999987</c:v>
                </c:pt>
                <c:pt idx="7">
                  <c:v>964.4224999999999</c:v>
                </c:pt>
                <c:pt idx="8">
                  <c:v>1011.4674999999999</c:v>
                </c:pt>
                <c:pt idx="9">
                  <c:v>1123.6320000000001</c:v>
                </c:pt>
                <c:pt idx="10">
                  <c:v>1757.8125</c:v>
                </c:pt>
                <c:pt idx="11">
                  <c:v>1801.9259999999999</c:v>
                </c:pt>
                <c:pt idx="12">
                  <c:v>1867.7760000000005</c:v>
                </c:pt>
                <c:pt idx="13">
                  <c:v>1935.05</c:v>
                </c:pt>
                <c:pt idx="14">
                  <c:v>2003.759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D8A4-064A-BA5F-8D45ECB4111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32714111"/>
        <c:axId val="1932781711"/>
      </c:lineChart>
      <c:catAx>
        <c:axId val="193271411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2781711"/>
        <c:crosses val="autoZero"/>
        <c:auto val="1"/>
        <c:lblAlgn val="ctr"/>
        <c:lblOffset val="100"/>
        <c:noMultiLvlLbl val="0"/>
      </c:catAx>
      <c:valAx>
        <c:axId val="1932781711"/>
        <c:scaling>
          <c:orientation val="minMax"/>
          <c:max val="3200"/>
          <c:min val="0"/>
        </c:scaling>
        <c:delete val="0"/>
        <c:axPos val="l"/>
        <c:numFmt formatCode="#,##0" sourceLinked="0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32714111"/>
        <c:crosses val="autoZero"/>
        <c:crossBetween val="midCat"/>
        <c:majorUnit val="1000"/>
        <c:minorUnit val="2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Tumor Volume Analysis (paper)'!$O$32</c:f>
              <c:strCache>
                <c:ptCount val="1"/>
                <c:pt idx="0">
                  <c:v>10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O$33:$O$47</c:f>
              <c:numCache>
                <c:formatCode>General</c:formatCode>
                <c:ptCount val="15"/>
                <c:pt idx="0">
                  <c:v>26.263999999999996</c:v>
                </c:pt>
                <c:pt idx="1">
                  <c:v>33.635000000000005</c:v>
                </c:pt>
                <c:pt idx="2">
                  <c:v>63.504000000000005</c:v>
                </c:pt>
                <c:pt idx="3">
                  <c:v>69.827999999999989</c:v>
                </c:pt>
                <c:pt idx="4">
                  <c:v>62.774999999999999</c:v>
                </c:pt>
                <c:pt idx="5">
                  <c:v>142.97</c:v>
                </c:pt>
                <c:pt idx="6">
                  <c:v>153</c:v>
                </c:pt>
                <c:pt idx="7">
                  <c:v>200.6875</c:v>
                </c:pt>
                <c:pt idx="8">
                  <c:v>224.26399999999995</c:v>
                </c:pt>
                <c:pt idx="9">
                  <c:v>264.65249999999997</c:v>
                </c:pt>
                <c:pt idx="10">
                  <c:v>340.70399999999995</c:v>
                </c:pt>
                <c:pt idx="11">
                  <c:v>386.63</c:v>
                </c:pt>
                <c:pt idx="12">
                  <c:v>426.27500000000003</c:v>
                </c:pt>
                <c:pt idx="13">
                  <c:v>476.25600000000009</c:v>
                </c:pt>
                <c:pt idx="14">
                  <c:v>506.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64F-2A4E-8BFD-7EB31502EEF5}"/>
            </c:ext>
          </c:extLst>
        </c:ser>
        <c:ser>
          <c:idx val="1"/>
          <c:order val="1"/>
          <c:tx>
            <c:strRef>
              <c:f>'Tumor Volume Analysis (paper)'!$P$32</c:f>
              <c:strCache>
                <c:ptCount val="1"/>
                <c:pt idx="0">
                  <c:v>11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P$33:$P$47</c:f>
              <c:numCache>
                <c:formatCode>General</c:formatCode>
                <c:ptCount val="15"/>
                <c:pt idx="0">
                  <c:v>24.505500000000001</c:v>
                </c:pt>
                <c:pt idx="1">
                  <c:v>23.400000000000002</c:v>
                </c:pt>
                <c:pt idx="2">
                  <c:v>25.466500000000003</c:v>
                </c:pt>
                <c:pt idx="3">
                  <c:v>24.3</c:v>
                </c:pt>
                <c:pt idx="4">
                  <c:v>23.127500000000001</c:v>
                </c:pt>
                <c:pt idx="5">
                  <c:v>37.569999999999993</c:v>
                </c:pt>
                <c:pt idx="6">
                  <c:v>41.037500000000001</c:v>
                </c:pt>
                <c:pt idx="7">
                  <c:v>46.93</c:v>
                </c:pt>
                <c:pt idx="8">
                  <c:v>45.36</c:v>
                </c:pt>
                <c:pt idx="9">
                  <c:v>51.261999999999993</c:v>
                </c:pt>
                <c:pt idx="10">
                  <c:v>72.600000000000009</c:v>
                </c:pt>
                <c:pt idx="11">
                  <c:v>83.942000000000007</c:v>
                </c:pt>
                <c:pt idx="12">
                  <c:v>96.25</c:v>
                </c:pt>
                <c:pt idx="13">
                  <c:v>101.4</c:v>
                </c:pt>
                <c:pt idx="14">
                  <c:v>113.4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64F-2A4E-8BFD-7EB31502EEF5}"/>
            </c:ext>
          </c:extLst>
        </c:ser>
        <c:ser>
          <c:idx val="2"/>
          <c:order val="2"/>
          <c:tx>
            <c:strRef>
              <c:f>'Tumor Volume Analysis (paper)'!$Q$32</c:f>
              <c:strCache>
                <c:ptCount val="1"/>
                <c:pt idx="0">
                  <c:v>12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Q$33:$Q$47</c:f>
              <c:numCache>
                <c:formatCode>General</c:formatCode>
                <c:ptCount val="15"/>
                <c:pt idx="0">
                  <c:v>51.2</c:v>
                </c:pt>
                <c:pt idx="1">
                  <c:v>52</c:v>
                </c:pt>
                <c:pt idx="2">
                  <c:v>57.33</c:v>
                </c:pt>
                <c:pt idx="3">
                  <c:v>52.951499999999996</c:v>
                </c:pt>
                <c:pt idx="4">
                  <c:v>51.2</c:v>
                </c:pt>
                <c:pt idx="5">
                  <c:v>69.862499999999997</c:v>
                </c:pt>
                <c:pt idx="6">
                  <c:v>78.419500000000014</c:v>
                </c:pt>
                <c:pt idx="7">
                  <c:v>82.944000000000003</c:v>
                </c:pt>
                <c:pt idx="8">
                  <c:v>92.335499999999982</c:v>
                </c:pt>
                <c:pt idx="9">
                  <c:v>104.97600000000001</c:v>
                </c:pt>
                <c:pt idx="10">
                  <c:v>116.032</c:v>
                </c:pt>
                <c:pt idx="11">
                  <c:v>127.83199999999999</c:v>
                </c:pt>
                <c:pt idx="12">
                  <c:v>138.6</c:v>
                </c:pt>
                <c:pt idx="13">
                  <c:v>146.97949999999997</c:v>
                </c:pt>
                <c:pt idx="14">
                  <c:v>164.7135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64F-2A4E-8BFD-7EB31502EEF5}"/>
            </c:ext>
          </c:extLst>
        </c:ser>
        <c:ser>
          <c:idx val="3"/>
          <c:order val="3"/>
          <c:tx>
            <c:strRef>
              <c:f>'Tumor Volume Analysis (paper)'!$R$32</c:f>
              <c:strCache>
                <c:ptCount val="1"/>
                <c:pt idx="0">
                  <c:v>13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R$33:$R$47</c:f>
              <c:numCache>
                <c:formatCode>General</c:formatCode>
                <c:ptCount val="15"/>
                <c:pt idx="0">
                  <c:v>89.464500000000015</c:v>
                </c:pt>
                <c:pt idx="1">
                  <c:v>89.464500000000015</c:v>
                </c:pt>
                <c:pt idx="2">
                  <c:v>96.768000000000001</c:v>
                </c:pt>
                <c:pt idx="3">
                  <c:v>113.14349999999999</c:v>
                </c:pt>
                <c:pt idx="4">
                  <c:v>110.00000000000001</c:v>
                </c:pt>
                <c:pt idx="5">
                  <c:v>112.21600000000002</c:v>
                </c:pt>
                <c:pt idx="6">
                  <c:v>125.38800000000001</c:v>
                </c:pt>
                <c:pt idx="7">
                  <c:v>137.98399999999998</c:v>
                </c:pt>
                <c:pt idx="8">
                  <c:v>149.69800000000001</c:v>
                </c:pt>
                <c:pt idx="9">
                  <c:v>153.06199999999998</c:v>
                </c:pt>
                <c:pt idx="10">
                  <c:v>171</c:v>
                </c:pt>
                <c:pt idx="11">
                  <c:v>178.60799999999998</c:v>
                </c:pt>
                <c:pt idx="12">
                  <c:v>194.56000000000003</c:v>
                </c:pt>
                <c:pt idx="13">
                  <c:v>192.49649999999997</c:v>
                </c:pt>
                <c:pt idx="14">
                  <c:v>207.025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64F-2A4E-8BFD-7EB31502EEF5}"/>
            </c:ext>
          </c:extLst>
        </c:ser>
        <c:ser>
          <c:idx val="4"/>
          <c:order val="4"/>
          <c:tx>
            <c:strRef>
              <c:f>'Tumor Volume Analysis (paper)'!$S$32</c:f>
              <c:strCache>
                <c:ptCount val="1"/>
                <c:pt idx="0">
                  <c:v>14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S$33:$S$47</c:f>
              <c:numCache>
                <c:formatCode>General</c:formatCode>
                <c:ptCount val="15"/>
                <c:pt idx="0">
                  <c:v>98.393999999999991</c:v>
                </c:pt>
                <c:pt idx="1">
                  <c:v>101.614</c:v>
                </c:pt>
                <c:pt idx="2">
                  <c:v>104.92750000000001</c:v>
                </c:pt>
                <c:pt idx="3">
                  <c:v>110.592</c:v>
                </c:pt>
                <c:pt idx="4">
                  <c:v>111.74399999999999</c:v>
                </c:pt>
                <c:pt idx="5">
                  <c:v>99.405000000000015</c:v>
                </c:pt>
                <c:pt idx="6">
                  <c:v>105.98399999999999</c:v>
                </c:pt>
                <c:pt idx="7">
                  <c:v>108.288</c:v>
                </c:pt>
                <c:pt idx="8">
                  <c:v>128.44000000000003</c:v>
                </c:pt>
                <c:pt idx="9">
                  <c:v>146.71249999999998</c:v>
                </c:pt>
                <c:pt idx="10">
                  <c:v>170.56900000000002</c:v>
                </c:pt>
                <c:pt idx="11">
                  <c:v>183.6</c:v>
                </c:pt>
                <c:pt idx="12">
                  <c:v>193.49199999999996</c:v>
                </c:pt>
                <c:pt idx="13">
                  <c:v>202.41899999999998</c:v>
                </c:pt>
                <c:pt idx="14">
                  <c:v>228.68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64F-2A4E-8BFD-7EB31502EEF5}"/>
            </c:ext>
          </c:extLst>
        </c:ser>
        <c:ser>
          <c:idx val="5"/>
          <c:order val="5"/>
          <c:tx>
            <c:strRef>
              <c:f>'Tumor Volume Analysis (paper)'!$T$32</c:f>
              <c:strCache>
                <c:ptCount val="1"/>
                <c:pt idx="0">
                  <c:v>15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T$33:$T$47</c:f>
              <c:numCache>
                <c:formatCode>General</c:formatCode>
                <c:ptCount val="15"/>
                <c:pt idx="0">
                  <c:v>132.5</c:v>
                </c:pt>
                <c:pt idx="1">
                  <c:v>207</c:v>
                </c:pt>
                <c:pt idx="2">
                  <c:v>228.84149999999997</c:v>
                </c:pt>
                <c:pt idx="3">
                  <c:v>232.56249999999997</c:v>
                </c:pt>
                <c:pt idx="4">
                  <c:v>294.02999999999997</c:v>
                </c:pt>
                <c:pt idx="5">
                  <c:v>496</c:v>
                </c:pt>
                <c:pt idx="6">
                  <c:v>508.47750000000002</c:v>
                </c:pt>
                <c:pt idx="7">
                  <c:v>541.28200000000004</c:v>
                </c:pt>
                <c:pt idx="8">
                  <c:v>646.62400000000002</c:v>
                </c:pt>
                <c:pt idx="9">
                  <c:v>680.4</c:v>
                </c:pt>
                <c:pt idx="10">
                  <c:v>970.2</c:v>
                </c:pt>
                <c:pt idx="11">
                  <c:v>988.76800000000003</c:v>
                </c:pt>
                <c:pt idx="12">
                  <c:v>1007.5119999999999</c:v>
                </c:pt>
                <c:pt idx="13">
                  <c:v>1057.4090000000001</c:v>
                </c:pt>
                <c:pt idx="14">
                  <c:v>1075.2305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464F-2A4E-8BFD-7EB31502EEF5}"/>
            </c:ext>
          </c:extLst>
        </c:ser>
        <c:ser>
          <c:idx val="6"/>
          <c:order val="6"/>
          <c:tx>
            <c:strRef>
              <c:f>'Tumor Volume Analysis (paper)'!$U$32</c:f>
              <c:strCache>
                <c:ptCount val="1"/>
                <c:pt idx="0">
                  <c:v>16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U$33:$U$47</c:f>
              <c:numCache>
                <c:formatCode>General</c:formatCode>
                <c:ptCount val="15"/>
                <c:pt idx="0">
                  <c:v>188.01250000000002</c:v>
                </c:pt>
                <c:pt idx="1">
                  <c:v>209.48400000000004</c:v>
                </c:pt>
                <c:pt idx="2">
                  <c:v>235.2</c:v>
                </c:pt>
                <c:pt idx="3">
                  <c:v>276.53800000000001</c:v>
                </c:pt>
                <c:pt idx="4">
                  <c:v>322.45199999999994</c:v>
                </c:pt>
                <c:pt idx="5">
                  <c:v>671.05799999999999</c:v>
                </c:pt>
                <c:pt idx="6">
                  <c:v>733.16250000000002</c:v>
                </c:pt>
                <c:pt idx="7">
                  <c:v>958.8125</c:v>
                </c:pt>
                <c:pt idx="8">
                  <c:v>1026.675</c:v>
                </c:pt>
                <c:pt idx="9">
                  <c:v>1076.2360000000001</c:v>
                </c:pt>
                <c:pt idx="10">
                  <c:v>1376.2560000000003</c:v>
                </c:pt>
                <c:pt idx="11">
                  <c:v>1715</c:v>
                </c:pt>
                <c:pt idx="12">
                  <c:v>1866.2400000000002</c:v>
                </c:pt>
                <c:pt idx="13">
                  <c:v>2015.1680000000001</c:v>
                </c:pt>
                <c:pt idx="14">
                  <c:v>2053.5925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464F-2A4E-8BFD-7EB31502EEF5}"/>
            </c:ext>
          </c:extLst>
        </c:ser>
        <c:ser>
          <c:idx val="7"/>
          <c:order val="7"/>
          <c:tx>
            <c:strRef>
              <c:f>'Tumor Volume Analysis (paper)'!$V$32</c:f>
              <c:strCache>
                <c:ptCount val="1"/>
                <c:pt idx="0">
                  <c:v>17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V$33:$V$47</c:f>
              <c:numCache>
                <c:formatCode>General</c:formatCode>
                <c:ptCount val="15"/>
                <c:pt idx="0">
                  <c:v>192.20000000000002</c:v>
                </c:pt>
                <c:pt idx="1">
                  <c:v>224.334</c:v>
                </c:pt>
                <c:pt idx="2">
                  <c:v>242.40600000000001</c:v>
                </c:pt>
                <c:pt idx="3">
                  <c:v>246.89500000000001</c:v>
                </c:pt>
                <c:pt idx="4">
                  <c:v>258.94399999999996</c:v>
                </c:pt>
                <c:pt idx="5">
                  <c:v>321.40800000000002</c:v>
                </c:pt>
                <c:pt idx="6">
                  <c:v>344.988</c:v>
                </c:pt>
                <c:pt idx="7">
                  <c:v>382.42050000000006</c:v>
                </c:pt>
                <c:pt idx="8">
                  <c:v>546.75</c:v>
                </c:pt>
                <c:pt idx="9">
                  <c:v>622.72800000000007</c:v>
                </c:pt>
                <c:pt idx="10">
                  <c:v>820.22799999999995</c:v>
                </c:pt>
                <c:pt idx="11">
                  <c:v>841.50149999999985</c:v>
                </c:pt>
                <c:pt idx="12">
                  <c:v>936.39599999999996</c:v>
                </c:pt>
                <c:pt idx="13">
                  <c:v>1000.6920000000001</c:v>
                </c:pt>
                <c:pt idx="14">
                  <c:v>1031.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464F-2A4E-8BFD-7EB31502EEF5}"/>
            </c:ext>
          </c:extLst>
        </c:ser>
        <c:ser>
          <c:idx val="8"/>
          <c:order val="8"/>
          <c:tx>
            <c:strRef>
              <c:f>'Tumor Volume Analysis (paper)'!$W$32</c:f>
              <c:strCache>
                <c:ptCount val="1"/>
                <c:pt idx="0">
                  <c:v>18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W$33:$W$47</c:f>
              <c:numCache>
                <c:formatCode>General</c:formatCode>
                <c:ptCount val="15"/>
                <c:pt idx="0">
                  <c:v>313.44950000000006</c:v>
                </c:pt>
                <c:pt idx="1">
                  <c:v>378.44999999999993</c:v>
                </c:pt>
                <c:pt idx="2">
                  <c:v>465.51999999999992</c:v>
                </c:pt>
                <c:pt idx="3">
                  <c:v>511.48799999999994</c:v>
                </c:pt>
                <c:pt idx="4">
                  <c:v>541.01749999999993</c:v>
                </c:pt>
                <c:pt idx="5">
                  <c:v>585.84400000000005</c:v>
                </c:pt>
                <c:pt idx="6">
                  <c:v>612.5625</c:v>
                </c:pt>
                <c:pt idx="7">
                  <c:v>665.85599999999999</c:v>
                </c:pt>
                <c:pt idx="8">
                  <c:v>722.13749999999993</c:v>
                </c:pt>
                <c:pt idx="9">
                  <c:v>719.26400000000012</c:v>
                </c:pt>
                <c:pt idx="10">
                  <c:v>775.28399999999999</c:v>
                </c:pt>
                <c:pt idx="11">
                  <c:v>822.31200000000013</c:v>
                </c:pt>
                <c:pt idx="12">
                  <c:v>859.09999999999991</c:v>
                </c:pt>
                <c:pt idx="13">
                  <c:v>912.98350000000016</c:v>
                </c:pt>
                <c:pt idx="14">
                  <c:v>968.831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464F-2A4E-8BFD-7EB31502EEF5}"/>
            </c:ext>
          </c:extLst>
        </c:ser>
        <c:ser>
          <c:idx val="9"/>
          <c:order val="9"/>
          <c:tx>
            <c:strRef>
              <c:f>'Tumor Volume Analysis (paper)'!$X$32</c:f>
              <c:strCache>
                <c:ptCount val="1"/>
                <c:pt idx="0">
                  <c:v>19</c:v>
                </c:pt>
              </c:strCache>
            </c:strRef>
          </c:tx>
          <c:spPr>
            <a:ln w="12700" cap="rnd">
              <a:solidFill>
                <a:srgbClr val="009193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33:$N$47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X$33:$X$47</c:f>
              <c:numCache>
                <c:formatCode>General</c:formatCode>
                <c:ptCount val="15"/>
                <c:pt idx="0">
                  <c:v>382.92500000000001</c:v>
                </c:pt>
                <c:pt idx="1">
                  <c:v>303.24</c:v>
                </c:pt>
                <c:pt idx="2">
                  <c:v>423.86399999999986</c:v>
                </c:pt>
                <c:pt idx="3">
                  <c:v>431.43299999999994</c:v>
                </c:pt>
                <c:pt idx="4">
                  <c:v>459.41800000000001</c:v>
                </c:pt>
                <c:pt idx="5">
                  <c:v>650.25</c:v>
                </c:pt>
                <c:pt idx="6">
                  <c:v>684.28050000000019</c:v>
                </c:pt>
                <c:pt idx="7">
                  <c:v>818.60349999999994</c:v>
                </c:pt>
                <c:pt idx="8">
                  <c:v>905.59349999999995</c:v>
                </c:pt>
                <c:pt idx="9">
                  <c:v>1024.9375</c:v>
                </c:pt>
                <c:pt idx="10">
                  <c:v>1351.6800000000003</c:v>
                </c:pt>
                <c:pt idx="11">
                  <c:v>1432.9434999999999</c:v>
                </c:pt>
                <c:pt idx="12">
                  <c:v>1485.8760000000002</c:v>
                </c:pt>
                <c:pt idx="13">
                  <c:v>1508.3040000000001</c:v>
                </c:pt>
                <c:pt idx="14">
                  <c:v>1599.696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464F-2A4E-8BFD-7EB31502EE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62120000"/>
        <c:axId val="2135142639"/>
      </c:lineChart>
      <c:catAx>
        <c:axId val="16212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35142639"/>
        <c:crosses val="autoZero"/>
        <c:auto val="1"/>
        <c:lblAlgn val="ctr"/>
        <c:lblOffset val="100"/>
        <c:noMultiLvlLbl val="0"/>
      </c:catAx>
      <c:valAx>
        <c:axId val="2135142639"/>
        <c:scaling>
          <c:orientation val="minMax"/>
          <c:max val="3200"/>
          <c:min val="0"/>
        </c:scaling>
        <c:delete val="0"/>
        <c:axPos val="l"/>
        <c:numFmt formatCode="#,##0" sourceLinked="0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2120000"/>
        <c:crosses val="autoZero"/>
        <c:crossBetween val="midCat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Tumor Volume Analysis (paper)'!$O$56</c:f>
              <c:strCache>
                <c:ptCount val="1"/>
                <c:pt idx="0">
                  <c:v>20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O$57:$O$71</c:f>
              <c:numCache>
                <c:formatCode>General</c:formatCode>
                <c:ptCount val="15"/>
                <c:pt idx="0">
                  <c:v>16.038000000000004</c:v>
                </c:pt>
                <c:pt idx="1">
                  <c:v>15.673500000000001</c:v>
                </c:pt>
                <c:pt idx="2">
                  <c:v>18.922499999999999</c:v>
                </c:pt>
                <c:pt idx="3">
                  <c:v>24.064000000000007</c:v>
                </c:pt>
                <c:pt idx="4">
                  <c:v>23.040000000000006</c:v>
                </c:pt>
                <c:pt idx="5">
                  <c:v>29.947499999999998</c:v>
                </c:pt>
                <c:pt idx="6">
                  <c:v>27.648000000000007</c:v>
                </c:pt>
                <c:pt idx="7">
                  <c:v>26.427500000000002</c:v>
                </c:pt>
                <c:pt idx="8">
                  <c:v>26.908000000000001</c:v>
                </c:pt>
                <c:pt idx="9">
                  <c:v>32.945999999999998</c:v>
                </c:pt>
                <c:pt idx="10">
                  <c:v>34.101999999999997</c:v>
                </c:pt>
                <c:pt idx="11">
                  <c:v>36.75</c:v>
                </c:pt>
                <c:pt idx="12">
                  <c:v>37.975000000000001</c:v>
                </c:pt>
                <c:pt idx="13">
                  <c:v>42.120000000000005</c:v>
                </c:pt>
                <c:pt idx="14">
                  <c:v>42.768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25-8543-82DC-720A5BF80E14}"/>
            </c:ext>
          </c:extLst>
        </c:ser>
        <c:ser>
          <c:idx val="1"/>
          <c:order val="1"/>
          <c:tx>
            <c:strRef>
              <c:f>'Tumor Volume Analysis (paper)'!$P$56</c:f>
              <c:strCache>
                <c:ptCount val="1"/>
                <c:pt idx="0">
                  <c:v>21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P$57:$P$71</c:f>
              <c:numCache>
                <c:formatCode>General</c:formatCode>
                <c:ptCount val="15"/>
                <c:pt idx="0">
                  <c:v>21.150000000000002</c:v>
                </c:pt>
                <c:pt idx="1">
                  <c:v>27.165999999999997</c:v>
                </c:pt>
                <c:pt idx="2">
                  <c:v>31.752000000000006</c:v>
                </c:pt>
                <c:pt idx="3">
                  <c:v>32.400000000000006</c:v>
                </c:pt>
                <c:pt idx="4">
                  <c:v>37.543999999999997</c:v>
                </c:pt>
                <c:pt idx="5">
                  <c:v>47.150999999999996</c:v>
                </c:pt>
                <c:pt idx="6">
                  <c:v>52.110999999999997</c:v>
                </c:pt>
                <c:pt idx="7">
                  <c:v>52</c:v>
                </c:pt>
                <c:pt idx="8">
                  <c:v>59.094000000000001</c:v>
                </c:pt>
                <c:pt idx="9">
                  <c:v>57.33</c:v>
                </c:pt>
                <c:pt idx="10">
                  <c:v>52</c:v>
                </c:pt>
                <c:pt idx="11">
                  <c:v>56.313499999999998</c:v>
                </c:pt>
                <c:pt idx="12">
                  <c:v>60.858000000000004</c:v>
                </c:pt>
                <c:pt idx="13">
                  <c:v>73.912499999999994</c:v>
                </c:pt>
                <c:pt idx="14">
                  <c:v>79.34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E25-8543-82DC-720A5BF80E14}"/>
            </c:ext>
          </c:extLst>
        </c:ser>
        <c:ser>
          <c:idx val="2"/>
          <c:order val="2"/>
          <c:tx>
            <c:strRef>
              <c:f>'Tumor Volume Analysis (paper)'!$Q$56</c:f>
              <c:strCache>
                <c:ptCount val="1"/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Q$57:$Q$71</c:f>
              <c:numCache>
                <c:formatCode>General</c:formatCode>
                <c:ptCount val="15"/>
                <c:pt idx="0">
                  <c:v>28.88</c:v>
                </c:pt>
                <c:pt idx="1">
                  <c:v>32.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E25-8543-82DC-720A5BF80E14}"/>
            </c:ext>
          </c:extLst>
        </c:ser>
        <c:ser>
          <c:idx val="3"/>
          <c:order val="3"/>
          <c:tx>
            <c:strRef>
              <c:f>'Tumor Volume Analysis (paper)'!$R$56</c:f>
              <c:strCache>
                <c:ptCount val="1"/>
                <c:pt idx="0">
                  <c:v>22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R$57:$R$71</c:f>
              <c:numCache>
                <c:formatCode>General</c:formatCode>
                <c:ptCount val="15"/>
                <c:pt idx="0">
                  <c:v>86.436000000000021</c:v>
                </c:pt>
                <c:pt idx="1">
                  <c:v>93.288000000000011</c:v>
                </c:pt>
                <c:pt idx="2">
                  <c:v>134.56</c:v>
                </c:pt>
                <c:pt idx="3">
                  <c:v>150.70049999999998</c:v>
                </c:pt>
                <c:pt idx="4">
                  <c:v>175.33750000000001</c:v>
                </c:pt>
                <c:pt idx="5">
                  <c:v>267.1875</c:v>
                </c:pt>
                <c:pt idx="6">
                  <c:v>292.03199999999998</c:v>
                </c:pt>
                <c:pt idx="7">
                  <c:v>361.67250000000007</c:v>
                </c:pt>
                <c:pt idx="8">
                  <c:v>391.98799999999994</c:v>
                </c:pt>
                <c:pt idx="9">
                  <c:v>439.61550000000005</c:v>
                </c:pt>
                <c:pt idx="10">
                  <c:v>566.63600000000019</c:v>
                </c:pt>
                <c:pt idx="11">
                  <c:v>576.24000000000012</c:v>
                </c:pt>
                <c:pt idx="12">
                  <c:v>629.44199999999989</c:v>
                </c:pt>
                <c:pt idx="13">
                  <c:v>696.63200000000006</c:v>
                </c:pt>
                <c:pt idx="14">
                  <c:v>766.324500000000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E25-8543-82DC-720A5BF80E14}"/>
            </c:ext>
          </c:extLst>
        </c:ser>
        <c:ser>
          <c:idx val="4"/>
          <c:order val="4"/>
          <c:tx>
            <c:strRef>
              <c:f>'Tumor Volume Analysis (paper)'!$S$56</c:f>
              <c:strCache>
                <c:ptCount val="1"/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S$57:$S$71</c:f>
              <c:numCache>
                <c:formatCode>General</c:formatCode>
                <c:ptCount val="15"/>
                <c:pt idx="0">
                  <c:v>97.196000000000026</c:v>
                </c:pt>
                <c:pt idx="1">
                  <c:v>97.92</c:v>
                </c:pt>
                <c:pt idx="2">
                  <c:v>101.376</c:v>
                </c:pt>
                <c:pt idx="3">
                  <c:v>101.614</c:v>
                </c:pt>
                <c:pt idx="4">
                  <c:v>109.44</c:v>
                </c:pt>
                <c:pt idx="5">
                  <c:v>103.684</c:v>
                </c:pt>
                <c:pt idx="6">
                  <c:v>101.25</c:v>
                </c:pt>
                <c:pt idx="7">
                  <c:v>94.298999999999992</c:v>
                </c:pt>
                <c:pt idx="8">
                  <c:v>100.672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E25-8543-82DC-720A5BF80E14}"/>
            </c:ext>
          </c:extLst>
        </c:ser>
        <c:ser>
          <c:idx val="5"/>
          <c:order val="5"/>
          <c:tx>
            <c:strRef>
              <c:f>'Tumor Volume Analysis (paper)'!$T$56</c:f>
              <c:strCache>
                <c:ptCount val="1"/>
                <c:pt idx="0">
                  <c:v>23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T$57:$T$71</c:f>
              <c:numCache>
                <c:formatCode>General</c:formatCode>
                <c:ptCount val="15"/>
                <c:pt idx="0">
                  <c:v>126.15</c:v>
                </c:pt>
                <c:pt idx="1">
                  <c:v>154.791</c:v>
                </c:pt>
                <c:pt idx="2">
                  <c:v>207.10350000000003</c:v>
                </c:pt>
                <c:pt idx="3">
                  <c:v>214.24500000000003</c:v>
                </c:pt>
                <c:pt idx="4">
                  <c:v>284.59200000000004</c:v>
                </c:pt>
                <c:pt idx="5">
                  <c:v>496.375</c:v>
                </c:pt>
                <c:pt idx="6">
                  <c:v>542.6260000000002</c:v>
                </c:pt>
                <c:pt idx="7">
                  <c:v>619.03800000000001</c:v>
                </c:pt>
                <c:pt idx="8">
                  <c:v>668.36700000000008</c:v>
                </c:pt>
                <c:pt idx="9">
                  <c:v>697.63200000000006</c:v>
                </c:pt>
                <c:pt idx="10">
                  <c:v>846.71999999999991</c:v>
                </c:pt>
                <c:pt idx="11">
                  <c:v>912.52500000000009</c:v>
                </c:pt>
                <c:pt idx="12">
                  <c:v>951.38549999999998</c:v>
                </c:pt>
                <c:pt idx="13">
                  <c:v>958.2299999999999</c:v>
                </c:pt>
                <c:pt idx="14">
                  <c:v>102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BE25-8543-82DC-720A5BF80E14}"/>
            </c:ext>
          </c:extLst>
        </c:ser>
        <c:ser>
          <c:idx val="6"/>
          <c:order val="6"/>
          <c:tx>
            <c:strRef>
              <c:f>'Tumor Volume Analysis (paper)'!$U$56</c:f>
              <c:strCache>
                <c:ptCount val="1"/>
                <c:pt idx="0">
                  <c:v>24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U$57:$U$71</c:f>
              <c:numCache>
                <c:formatCode>General</c:formatCode>
                <c:ptCount val="15"/>
                <c:pt idx="0">
                  <c:v>166.20799999999997</c:v>
                </c:pt>
                <c:pt idx="1">
                  <c:v>204.65499999999997</c:v>
                </c:pt>
                <c:pt idx="2">
                  <c:v>276.85000000000002</c:v>
                </c:pt>
                <c:pt idx="3">
                  <c:v>300.67200000000003</c:v>
                </c:pt>
                <c:pt idx="4">
                  <c:v>343.67200000000003</c:v>
                </c:pt>
                <c:pt idx="5">
                  <c:v>496.375</c:v>
                </c:pt>
                <c:pt idx="6">
                  <c:v>505.4</c:v>
                </c:pt>
                <c:pt idx="7">
                  <c:v>583.15950000000009</c:v>
                </c:pt>
                <c:pt idx="8">
                  <c:v>606.95949999999993</c:v>
                </c:pt>
                <c:pt idx="9">
                  <c:v>654.36800000000005</c:v>
                </c:pt>
                <c:pt idx="10">
                  <c:v>730.34</c:v>
                </c:pt>
                <c:pt idx="11">
                  <c:v>792.55</c:v>
                </c:pt>
                <c:pt idx="12">
                  <c:v>834.17599999999993</c:v>
                </c:pt>
                <c:pt idx="13">
                  <c:v>870.73200000000008</c:v>
                </c:pt>
                <c:pt idx="14">
                  <c:v>915.0080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BE25-8543-82DC-720A5BF80E14}"/>
            </c:ext>
          </c:extLst>
        </c:ser>
        <c:ser>
          <c:idx val="7"/>
          <c:order val="7"/>
          <c:tx>
            <c:strRef>
              <c:f>'Tumor Volume Analysis (paper)'!$V$56</c:f>
              <c:strCache>
                <c:ptCount val="1"/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V$57:$V$71</c:f>
              <c:numCache>
                <c:formatCode>General</c:formatCode>
                <c:ptCount val="15"/>
                <c:pt idx="0">
                  <c:v>191.66399999999999</c:v>
                </c:pt>
                <c:pt idx="1">
                  <c:v>212.70399999999995</c:v>
                </c:pt>
                <c:pt idx="2">
                  <c:v>248.83199999999999</c:v>
                </c:pt>
                <c:pt idx="3">
                  <c:v>288.8</c:v>
                </c:pt>
                <c:pt idx="4">
                  <c:v>344.45249999999999</c:v>
                </c:pt>
                <c:pt idx="5">
                  <c:v>473.8125</c:v>
                </c:pt>
                <c:pt idx="6">
                  <c:v>485.98000000000008</c:v>
                </c:pt>
                <c:pt idx="7">
                  <c:v>505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BE25-8543-82DC-720A5BF80E14}"/>
            </c:ext>
          </c:extLst>
        </c:ser>
        <c:ser>
          <c:idx val="8"/>
          <c:order val="8"/>
          <c:tx>
            <c:strRef>
              <c:f>'Tumor Volume Analysis (paper)'!$W$56</c:f>
              <c:strCache>
                <c:ptCount val="1"/>
                <c:pt idx="0">
                  <c:v>28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W$57:$W$71</c:f>
              <c:numCache>
                <c:formatCode>General</c:formatCode>
                <c:ptCount val="15"/>
                <c:pt idx="0">
                  <c:v>284.75200000000001</c:v>
                </c:pt>
                <c:pt idx="1">
                  <c:v>295.3125</c:v>
                </c:pt>
                <c:pt idx="2">
                  <c:v>364.8</c:v>
                </c:pt>
                <c:pt idx="3">
                  <c:v>370.69650000000001</c:v>
                </c:pt>
                <c:pt idx="4">
                  <c:v>377.25749999999999</c:v>
                </c:pt>
                <c:pt idx="5">
                  <c:v>435.21749999999992</c:v>
                </c:pt>
                <c:pt idx="6">
                  <c:v>442.78649999999988</c:v>
                </c:pt>
                <c:pt idx="7">
                  <c:v>475.26000000000005</c:v>
                </c:pt>
                <c:pt idx="8">
                  <c:v>483.18100000000004</c:v>
                </c:pt>
                <c:pt idx="9">
                  <c:v>472.38400000000007</c:v>
                </c:pt>
                <c:pt idx="10">
                  <c:v>533.2319999999998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BE25-8543-82DC-720A5BF80E14}"/>
            </c:ext>
          </c:extLst>
        </c:ser>
        <c:ser>
          <c:idx val="9"/>
          <c:order val="9"/>
          <c:tx>
            <c:strRef>
              <c:f>'Tumor Volume Analysis (paper)'!$X$56</c:f>
              <c:strCache>
                <c:ptCount val="1"/>
                <c:pt idx="0">
                  <c:v>25</c:v>
                </c:pt>
              </c:strCache>
            </c:strRef>
          </c:tx>
          <c:spPr>
            <a:ln w="12700" cap="rnd">
              <a:solidFill>
                <a:srgbClr val="FF7E79"/>
              </a:solidFill>
              <a:round/>
            </a:ln>
            <a:effectLst/>
          </c:spPr>
          <c:marker>
            <c:symbol val="none"/>
          </c:marker>
          <c:cat>
            <c:numRef>
              <c:f>'Tumor Volume Analysis (paper)'!$N$57:$N$71</c:f>
              <c:numCache>
                <c:formatCode>General</c:formatCode>
                <c:ptCount val="1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4</c:v>
                </c:pt>
                <c:pt idx="11">
                  <c:v>15</c:v>
                </c:pt>
                <c:pt idx="12">
                  <c:v>16</c:v>
                </c:pt>
                <c:pt idx="13">
                  <c:v>17</c:v>
                </c:pt>
                <c:pt idx="14">
                  <c:v>18</c:v>
                </c:pt>
              </c:numCache>
            </c:numRef>
          </c:cat>
          <c:val>
            <c:numRef>
              <c:f>'Tumor Volume Analysis (paper)'!$X$57:$X$71</c:f>
              <c:numCache>
                <c:formatCode>General</c:formatCode>
                <c:ptCount val="15"/>
                <c:pt idx="0">
                  <c:v>372.4</c:v>
                </c:pt>
                <c:pt idx="1">
                  <c:v>393.98399999999998</c:v>
                </c:pt>
                <c:pt idx="2">
                  <c:v>418.91400000000004</c:v>
                </c:pt>
                <c:pt idx="3">
                  <c:v>427.5</c:v>
                </c:pt>
                <c:pt idx="4">
                  <c:v>447.63950000000006</c:v>
                </c:pt>
                <c:pt idx="5">
                  <c:v>486.4</c:v>
                </c:pt>
                <c:pt idx="6">
                  <c:v>492.07499999999999</c:v>
                </c:pt>
                <c:pt idx="7">
                  <c:v>480</c:v>
                </c:pt>
                <c:pt idx="8">
                  <c:v>520.11950000000013</c:v>
                </c:pt>
                <c:pt idx="9">
                  <c:v>610.16999999999996</c:v>
                </c:pt>
                <c:pt idx="10">
                  <c:v>559.9375</c:v>
                </c:pt>
                <c:pt idx="11">
                  <c:v>569.49199999999996</c:v>
                </c:pt>
                <c:pt idx="12">
                  <c:v>631.79999999999995</c:v>
                </c:pt>
                <c:pt idx="13">
                  <c:v>698.0440000000001</c:v>
                </c:pt>
                <c:pt idx="14">
                  <c:v>748.0154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9-BE25-8543-82DC-720A5BF80E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909397951"/>
        <c:axId val="1908480047"/>
      </c:lineChart>
      <c:catAx>
        <c:axId val="190939795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8480047"/>
        <c:crosses val="autoZero"/>
        <c:auto val="1"/>
        <c:lblAlgn val="ctr"/>
        <c:lblOffset val="100"/>
        <c:noMultiLvlLbl val="0"/>
      </c:catAx>
      <c:valAx>
        <c:axId val="1908480047"/>
        <c:scaling>
          <c:orientation val="minMax"/>
          <c:max val="3200"/>
          <c:min val="0"/>
        </c:scaling>
        <c:delete val="0"/>
        <c:axPos val="l"/>
        <c:numFmt formatCode="#,##0" sourceLinked="0"/>
        <c:majorTickMark val="in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939795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211391-BB7C-E947-AA9E-BB08191871A3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143000"/>
            <a:ext cx="2047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ECE02E-D798-A544-842D-50672B18D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287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FE664CC-816F-134A-B2E0-1A0A6B40452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327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0658" y="1646133"/>
            <a:ext cx="5674122" cy="3501813"/>
          </a:xfrm>
        </p:spPr>
        <p:txBody>
          <a:bodyPr anchor="b"/>
          <a:lstStyle>
            <a:lvl1pPr algn="ctr"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4430" y="5282989"/>
            <a:ext cx="5006579" cy="2428451"/>
          </a:xfrm>
        </p:spPr>
        <p:txBody>
          <a:bodyPr/>
          <a:lstStyle>
            <a:lvl1pPr marL="0" indent="0" algn="ctr">
              <a:buNone/>
              <a:defRPr sz="1752"/>
            </a:lvl1pPr>
            <a:lvl2pPr marL="333756" indent="0" algn="ctr">
              <a:buNone/>
              <a:defRPr sz="1460"/>
            </a:lvl2pPr>
            <a:lvl3pPr marL="667512" indent="0" algn="ctr">
              <a:buNone/>
              <a:defRPr sz="1314"/>
            </a:lvl3pPr>
            <a:lvl4pPr marL="1001268" indent="0" algn="ctr">
              <a:buNone/>
              <a:defRPr sz="1168"/>
            </a:lvl4pPr>
            <a:lvl5pPr marL="1335024" indent="0" algn="ctr">
              <a:buNone/>
              <a:defRPr sz="1168"/>
            </a:lvl5pPr>
            <a:lvl6pPr marL="1668780" indent="0" algn="ctr">
              <a:buNone/>
              <a:defRPr sz="1168"/>
            </a:lvl6pPr>
            <a:lvl7pPr marL="2002536" indent="0" algn="ctr">
              <a:buNone/>
              <a:defRPr sz="1168"/>
            </a:lvl7pPr>
            <a:lvl8pPr marL="2336292" indent="0" algn="ctr">
              <a:buNone/>
              <a:defRPr sz="1168"/>
            </a:lvl8pPr>
            <a:lvl9pPr marL="2670048" indent="0" algn="ctr">
              <a:buNone/>
              <a:defRPr sz="11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3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0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7111" y="535517"/>
            <a:ext cx="1439391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8937" y="535517"/>
            <a:ext cx="4234731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85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748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60" y="2507618"/>
            <a:ext cx="5757565" cy="4184014"/>
          </a:xfrm>
        </p:spPr>
        <p:txBody>
          <a:bodyPr anchor="b"/>
          <a:lstStyle>
            <a:lvl1pPr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460" y="6731215"/>
            <a:ext cx="5757565" cy="2200274"/>
          </a:xfrm>
        </p:spPr>
        <p:txBody>
          <a:bodyPr/>
          <a:lstStyle>
            <a:lvl1pPr marL="0" indent="0">
              <a:buNone/>
              <a:defRPr sz="1752">
                <a:solidFill>
                  <a:schemeClr val="tx1"/>
                </a:solidFill>
              </a:defRPr>
            </a:lvl1pPr>
            <a:lvl2pPr marL="333756" indent="0">
              <a:buNone/>
              <a:defRPr sz="1460">
                <a:solidFill>
                  <a:schemeClr val="tx1">
                    <a:tint val="75000"/>
                  </a:schemeClr>
                </a:solidFill>
              </a:defRPr>
            </a:lvl2pPr>
            <a:lvl3pPr marL="667512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3pPr>
            <a:lvl4pPr marL="100126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4pPr>
            <a:lvl5pPr marL="1335024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5pPr>
            <a:lvl6pPr marL="1668780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6pPr>
            <a:lvl7pPr marL="2002536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7pPr>
            <a:lvl8pPr marL="2336292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8pPr>
            <a:lvl9pPr marL="267004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80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8936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9441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28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35519"/>
            <a:ext cx="575756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9806" y="2465706"/>
            <a:ext cx="2824023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9806" y="3674110"/>
            <a:ext cx="282402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441" y="2465706"/>
            <a:ext cx="2837931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441" y="3674110"/>
            <a:ext cx="2837931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23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09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7931" y="1448226"/>
            <a:ext cx="3379440" cy="7147983"/>
          </a:xfrm>
        </p:spPr>
        <p:txBody>
          <a:bodyPr/>
          <a:lstStyle>
            <a:lvl1pPr>
              <a:defRPr sz="2336"/>
            </a:lvl1pPr>
            <a:lvl2pPr>
              <a:defRPr sz="2044"/>
            </a:lvl2pPr>
            <a:lvl3pPr>
              <a:defRPr sz="1752"/>
            </a:lvl3pPr>
            <a:lvl4pPr>
              <a:defRPr sz="1460"/>
            </a:lvl4pPr>
            <a:lvl5pPr>
              <a:defRPr sz="1460"/>
            </a:lvl5pPr>
            <a:lvl6pPr>
              <a:defRPr sz="1460"/>
            </a:lvl6pPr>
            <a:lvl7pPr>
              <a:defRPr sz="1460"/>
            </a:lvl7pPr>
            <a:lvl8pPr>
              <a:defRPr sz="1460"/>
            </a:lvl8pPr>
            <a:lvl9pPr>
              <a:defRPr sz="14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69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7931" y="1448226"/>
            <a:ext cx="3379440" cy="7147983"/>
          </a:xfrm>
        </p:spPr>
        <p:txBody>
          <a:bodyPr anchor="t"/>
          <a:lstStyle>
            <a:lvl1pPr marL="0" indent="0">
              <a:buNone/>
              <a:defRPr sz="2336"/>
            </a:lvl1pPr>
            <a:lvl2pPr marL="333756" indent="0">
              <a:buNone/>
              <a:defRPr sz="2044"/>
            </a:lvl2pPr>
            <a:lvl3pPr marL="667512" indent="0">
              <a:buNone/>
              <a:defRPr sz="1752"/>
            </a:lvl3pPr>
            <a:lvl4pPr marL="1001268" indent="0">
              <a:buNone/>
              <a:defRPr sz="1460"/>
            </a:lvl4pPr>
            <a:lvl5pPr marL="1335024" indent="0">
              <a:buNone/>
              <a:defRPr sz="1460"/>
            </a:lvl5pPr>
            <a:lvl6pPr marL="1668780" indent="0">
              <a:buNone/>
              <a:defRPr sz="1460"/>
            </a:lvl6pPr>
            <a:lvl7pPr marL="2002536" indent="0">
              <a:buNone/>
              <a:defRPr sz="1460"/>
            </a:lvl7pPr>
            <a:lvl8pPr marL="2336292" indent="0">
              <a:buNone/>
              <a:defRPr sz="1460"/>
            </a:lvl8pPr>
            <a:lvl9pPr marL="2670048" indent="0">
              <a:buNone/>
              <a:defRPr sz="14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0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8937" y="535519"/>
            <a:ext cx="575756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937" y="2677584"/>
            <a:ext cx="575756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8936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1239" y="9322649"/>
            <a:ext cx="22529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4528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989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67512" rtl="0" eaLnBrk="1" latinLnBrk="0" hangingPunct="1">
        <a:lnSpc>
          <a:spcPct val="90000"/>
        </a:lnSpc>
        <a:spcBef>
          <a:spcPct val="0"/>
        </a:spcBef>
        <a:buNone/>
        <a:defRPr sz="3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878" indent="-166878" algn="l" defTabSz="667512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044" kern="1200">
          <a:solidFill>
            <a:schemeClr val="tx1"/>
          </a:solidFill>
          <a:latin typeface="+mn-lt"/>
          <a:ea typeface="+mn-ea"/>
          <a:cs typeface="+mn-cs"/>
        </a:defRPr>
      </a:lvl1pPr>
      <a:lvl2pPr marL="50063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752" kern="1200">
          <a:solidFill>
            <a:schemeClr val="tx1"/>
          </a:solidFill>
          <a:latin typeface="+mn-lt"/>
          <a:ea typeface="+mn-ea"/>
          <a:cs typeface="+mn-cs"/>
        </a:defRPr>
      </a:lvl2pPr>
      <a:lvl3pPr marL="83439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3pPr>
      <a:lvl4pPr marL="116814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501902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835658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16941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50317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83692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1pPr>
      <a:lvl2pPr marL="33375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2pPr>
      <a:lvl3pPr marL="66751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3pPr>
      <a:lvl4pPr marL="100126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335024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66878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00253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33629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67004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chart" Target="../charts/chart3.xml"/><Relationship Id="rId2" Type="http://schemas.openxmlformats.org/officeDocument/2006/relationships/image" Target="../media/image1.tif"/><Relationship Id="rId16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chart" Target="../charts/chart1.xml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036BA1-7537-7391-CD5E-24424130B1C3}"/>
              </a:ext>
            </a:extLst>
          </p:cNvPr>
          <p:cNvSpPr txBox="1"/>
          <p:nvPr/>
        </p:nvSpPr>
        <p:spPr>
          <a:xfrm>
            <a:off x="96989" y="117851"/>
            <a:ext cx="22159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543EF363-65CD-E947-38BE-EDCF7AF35BB5}"/>
              </a:ext>
            </a:extLst>
          </p:cNvPr>
          <p:cNvGrpSpPr/>
          <p:nvPr/>
        </p:nvGrpSpPr>
        <p:grpSpPr>
          <a:xfrm>
            <a:off x="528129" y="876732"/>
            <a:ext cx="5361244" cy="3139810"/>
            <a:chOff x="625625" y="5689203"/>
            <a:chExt cx="5361244" cy="3139810"/>
          </a:xfrm>
        </p:grpSpPr>
        <p:pic>
          <p:nvPicPr>
            <p:cNvPr id="71" name="Picture 70">
              <a:extLst>
                <a:ext uri="{FF2B5EF4-FFF2-40B4-BE49-F238E27FC236}">
                  <a16:creationId xmlns:a16="http://schemas.microsoft.com/office/drawing/2014/main" id="{A0E32A65-5884-CDF3-7C8E-05249082BE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/>
            <a:stretch/>
          </p:blipFill>
          <p:spPr>
            <a:xfrm>
              <a:off x="4860296" y="7480255"/>
              <a:ext cx="925391" cy="1321435"/>
            </a:xfrm>
            <a:prstGeom prst="rect">
              <a:avLst/>
            </a:prstGeom>
          </p:spPr>
        </p:pic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89789F20-0805-1DD3-9C9E-899DB66114A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393584" y="6229000"/>
              <a:ext cx="1005840" cy="1016937"/>
              <a:chOff x="881536" y="2955289"/>
              <a:chExt cx="1315540" cy="1330054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2334ECCA-C969-EF26-4D74-3453874EF2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52805" y="2955289"/>
                <a:ext cx="638069" cy="645261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A31EC13F-4A43-6E50-1C19-3264EAE58F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552347" y="3638493"/>
                <a:ext cx="644729" cy="646850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C20076F1-46B3-EA28-C5BB-13A1FBF0D9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81536" y="2959203"/>
                <a:ext cx="621733" cy="638913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4284631A-479B-4F09-B2EB-DD6764279E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81536" y="3640982"/>
                <a:ext cx="628482" cy="638913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4C00A15-D100-575F-5FBD-F8069D19460F}"/>
                </a:ext>
              </a:extLst>
            </p:cNvPr>
            <p:cNvSpPr txBox="1"/>
            <p:nvPr/>
          </p:nvSpPr>
          <p:spPr>
            <a:xfrm>
              <a:off x="3706022" y="5689203"/>
              <a:ext cx="6989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EC931B3-C77A-FF7B-0661-BF1BBF416F1B}"/>
                </a:ext>
              </a:extLst>
            </p:cNvPr>
            <p:cNvSpPr txBox="1"/>
            <p:nvPr/>
          </p:nvSpPr>
          <p:spPr>
            <a:xfrm>
              <a:off x="625625" y="5708669"/>
              <a:ext cx="69893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46803F3-8D43-26C8-F781-9D732857E6F0}"/>
                </a:ext>
              </a:extLst>
            </p:cNvPr>
            <p:cNvSpPr txBox="1"/>
            <p:nvPr/>
          </p:nvSpPr>
          <p:spPr>
            <a:xfrm>
              <a:off x="3878180" y="5988895"/>
              <a:ext cx="7136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hRNA: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C37D6196-5C3D-A800-0A62-5AE8970899B2}"/>
                </a:ext>
              </a:extLst>
            </p:cNvPr>
            <p:cNvSpPr txBox="1"/>
            <p:nvPr/>
          </p:nvSpPr>
          <p:spPr>
            <a:xfrm>
              <a:off x="4356195" y="6003255"/>
              <a:ext cx="6447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F501BDD-1F6A-6F52-056E-3E51ED3888A8}"/>
                </a:ext>
              </a:extLst>
            </p:cNvPr>
            <p:cNvSpPr txBox="1"/>
            <p:nvPr/>
          </p:nvSpPr>
          <p:spPr>
            <a:xfrm>
              <a:off x="4889380" y="600496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 10</a:t>
              </a:r>
            </a:p>
          </p:txBody>
        </p:sp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BE41E81A-E949-D5A3-F2BB-6560E156124D}"/>
                </a:ext>
              </a:extLst>
            </p:cNvPr>
            <p:cNvGrpSpPr/>
            <p:nvPr/>
          </p:nvGrpSpPr>
          <p:grpSpPr>
            <a:xfrm>
              <a:off x="901665" y="6030490"/>
              <a:ext cx="1612317" cy="1216942"/>
              <a:chOff x="698083" y="6031216"/>
              <a:chExt cx="1612317" cy="1216942"/>
            </a:xfrm>
          </p:grpSpPr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6A97176E-CD08-4EBB-90BA-E3AF41AC25F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304560" y="6228035"/>
                <a:ext cx="1005840" cy="1020123"/>
                <a:chOff x="3798653" y="4759634"/>
                <a:chExt cx="1246284" cy="1263980"/>
              </a:xfrm>
            </p:grpSpPr>
            <p:pic>
              <p:nvPicPr>
                <p:cNvPr id="64" name="Picture 63">
                  <a:extLst>
                    <a:ext uri="{FF2B5EF4-FFF2-40B4-BE49-F238E27FC236}">
                      <a16:creationId xmlns:a16="http://schemas.microsoft.com/office/drawing/2014/main" id="{298031CC-A652-8C13-548D-F97D4540B50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798653" y="5407071"/>
                  <a:ext cx="602390" cy="616543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pic>
              <p:nvPicPr>
                <p:cNvPr id="65" name="Picture 64">
                  <a:extLst>
                    <a:ext uri="{FF2B5EF4-FFF2-40B4-BE49-F238E27FC236}">
                      <a16:creationId xmlns:a16="http://schemas.microsoft.com/office/drawing/2014/main" id="{459C3E73-D901-9570-039B-A0989D49688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798653" y="4759671"/>
                  <a:ext cx="602390" cy="610345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pic>
              <p:nvPicPr>
                <p:cNvPr id="66" name="Picture 65">
                  <a:extLst>
                    <a:ext uri="{FF2B5EF4-FFF2-40B4-BE49-F238E27FC236}">
                      <a16:creationId xmlns:a16="http://schemas.microsoft.com/office/drawing/2014/main" id="{86097217-3809-C652-67B0-8FF981284A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4442146" y="4759634"/>
                  <a:ext cx="602390" cy="610345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pic>
              <p:nvPicPr>
                <p:cNvPr id="67" name="Picture 66">
                  <a:extLst>
                    <a:ext uri="{FF2B5EF4-FFF2-40B4-BE49-F238E27FC236}">
                      <a16:creationId xmlns:a16="http://schemas.microsoft.com/office/drawing/2014/main" id="{9EFD2F05-7785-60B8-4349-4341072068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4442146" y="5407071"/>
                  <a:ext cx="602791" cy="610345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</p:grp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10A9BD42-D794-D6F6-164E-2A11C66A66F5}"/>
                  </a:ext>
                </a:extLst>
              </p:cNvPr>
              <p:cNvSpPr txBox="1"/>
              <p:nvPr/>
            </p:nvSpPr>
            <p:spPr>
              <a:xfrm flipH="1">
                <a:off x="816090" y="6873640"/>
                <a:ext cx="55656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 Dox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805720FC-ECE0-C61C-33E4-507E6E1EAA18}"/>
                  </a:ext>
                </a:extLst>
              </p:cNvPr>
              <p:cNvSpPr txBox="1"/>
              <p:nvPr/>
            </p:nvSpPr>
            <p:spPr>
              <a:xfrm flipH="1">
                <a:off x="836184" y="6388935"/>
                <a:ext cx="5212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 Dox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C0AA9A08-C5F5-192D-1A77-55C1758E7C73}"/>
                  </a:ext>
                </a:extLst>
              </p:cNvPr>
              <p:cNvSpPr txBox="1"/>
              <p:nvPr/>
            </p:nvSpPr>
            <p:spPr>
              <a:xfrm>
                <a:off x="698083" y="6031216"/>
                <a:ext cx="71365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shRNA: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DE77B2E-80A5-B658-61FA-D7A58F4A6821}"/>
                  </a:ext>
                </a:extLst>
              </p:cNvPr>
              <p:cNvSpPr txBox="1"/>
              <p:nvPr/>
            </p:nvSpPr>
            <p:spPr>
              <a:xfrm>
                <a:off x="1289427" y="6033998"/>
                <a:ext cx="64472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7E41D639-E573-414E-395E-4C367BF4F73F}"/>
                  </a:ext>
                </a:extLst>
              </p:cNvPr>
              <p:cNvSpPr txBox="1"/>
              <p:nvPr/>
            </p:nvSpPr>
            <p:spPr>
              <a:xfrm>
                <a:off x="1822612" y="6035704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# 10</a:t>
                </a:r>
              </a:p>
            </p:txBody>
          </p:sp>
        </p:grpSp>
        <p:pic>
          <p:nvPicPr>
            <p:cNvPr id="120" name="Picture 119">
              <a:extLst>
                <a:ext uri="{FF2B5EF4-FFF2-40B4-BE49-F238E27FC236}">
                  <a16:creationId xmlns:a16="http://schemas.microsoft.com/office/drawing/2014/main" id="{E625411F-0F6D-477C-78CE-F02F9F8FCF2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44425" y="7426562"/>
              <a:ext cx="925391" cy="1391736"/>
            </a:xfrm>
            <a:prstGeom prst="rect">
              <a:avLst/>
            </a:prstGeom>
          </p:spPr>
        </p:pic>
        <p:pic>
          <p:nvPicPr>
            <p:cNvPr id="121" name="Picture 120">
              <a:extLst>
                <a:ext uri="{FF2B5EF4-FFF2-40B4-BE49-F238E27FC236}">
                  <a16:creationId xmlns:a16="http://schemas.microsoft.com/office/drawing/2014/main" id="{D11775FB-EEE4-21FD-E83A-76D032FF8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1959011" y="7433596"/>
              <a:ext cx="959671" cy="1384702"/>
            </a:xfrm>
            <a:prstGeom prst="rect">
              <a:avLst/>
            </a:prstGeom>
          </p:spPr>
        </p:pic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F7D24199-FFA8-82DE-B32A-489E67ECE8CE}"/>
                </a:ext>
              </a:extLst>
            </p:cNvPr>
            <p:cNvSpPr txBox="1"/>
            <p:nvPr/>
          </p:nvSpPr>
          <p:spPr>
            <a:xfrm>
              <a:off x="1087192" y="5731114"/>
              <a:ext cx="18565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792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et-On NMT1 shRNA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E07B2A54-89F8-84F9-1FFF-3129E662C628}"/>
                </a:ext>
              </a:extLst>
            </p:cNvPr>
            <p:cNvSpPr txBox="1"/>
            <p:nvPr/>
          </p:nvSpPr>
          <p:spPr>
            <a:xfrm>
              <a:off x="1171311" y="7180792"/>
              <a:ext cx="174625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 shRNA</a:t>
              </a:r>
            </a:p>
            <a:p>
              <a:endParaRPr lang="en-US" sz="800" dirty="0"/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A554366E-0910-EF0C-96AE-29719F3CA4B2}"/>
                </a:ext>
              </a:extLst>
            </p:cNvPr>
            <p:cNvSpPr txBox="1"/>
            <p:nvPr/>
          </p:nvSpPr>
          <p:spPr>
            <a:xfrm>
              <a:off x="1712748" y="7192996"/>
              <a:ext cx="140481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MT1#10 shRNA</a:t>
              </a:r>
            </a:p>
            <a:p>
              <a:endParaRPr lang="en-US" sz="800" dirty="0"/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8A5481E2-905C-DF96-6578-F2DDAA2ABDA2}"/>
                </a:ext>
              </a:extLst>
            </p:cNvPr>
            <p:cNvSpPr txBox="1"/>
            <p:nvPr/>
          </p:nvSpPr>
          <p:spPr>
            <a:xfrm flipH="1">
              <a:off x="3921092" y="6877677"/>
              <a:ext cx="5565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 Dox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838C1C2-04D4-B22D-E779-D65DD14C34D5}"/>
                </a:ext>
              </a:extLst>
            </p:cNvPr>
            <p:cNvSpPr txBox="1"/>
            <p:nvPr/>
          </p:nvSpPr>
          <p:spPr>
            <a:xfrm flipH="1">
              <a:off x="3941186" y="6392972"/>
              <a:ext cx="521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Dox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17531B9B-8B2D-C2D7-782A-04D87C35602C}"/>
                </a:ext>
              </a:extLst>
            </p:cNvPr>
            <p:cNvSpPr txBox="1"/>
            <p:nvPr/>
          </p:nvSpPr>
          <p:spPr>
            <a:xfrm>
              <a:off x="3972581" y="5727985"/>
              <a:ext cx="1901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CC44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et-On NMT1 shRNA</a:t>
              </a:r>
            </a:p>
          </p:txBody>
        </p:sp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7295D6E-C48D-0954-9069-F67C9962874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/>
            <a:stretch/>
          </p:blipFill>
          <p:spPr>
            <a:xfrm>
              <a:off x="3864890" y="7475387"/>
              <a:ext cx="1002208" cy="1353626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989BDAA-093A-53EE-0716-F274DBECE78E}"/>
                </a:ext>
              </a:extLst>
            </p:cNvPr>
            <p:cNvSpPr txBox="1"/>
            <p:nvPr/>
          </p:nvSpPr>
          <p:spPr>
            <a:xfrm>
              <a:off x="4075527" y="7208589"/>
              <a:ext cx="1320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 shRNA</a:t>
              </a:r>
            </a:p>
            <a:p>
              <a:endParaRPr lang="en-US" sz="8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BBA6471-5F01-45BF-DD11-294FDB11B446}"/>
                </a:ext>
              </a:extLst>
            </p:cNvPr>
            <p:cNvSpPr txBox="1"/>
            <p:nvPr/>
          </p:nvSpPr>
          <p:spPr>
            <a:xfrm>
              <a:off x="4665917" y="7204423"/>
              <a:ext cx="132095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MT1#10 shRNA</a:t>
              </a:r>
            </a:p>
            <a:p>
              <a:endParaRPr lang="en-US" sz="800" dirty="0"/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F83BF049-A207-E79B-7569-EE7D7A96F488}"/>
              </a:ext>
            </a:extLst>
          </p:cNvPr>
          <p:cNvGrpSpPr/>
          <p:nvPr/>
        </p:nvGrpSpPr>
        <p:grpSpPr>
          <a:xfrm>
            <a:off x="1995886" y="6057900"/>
            <a:ext cx="2683666" cy="2166571"/>
            <a:chOff x="3550344" y="4255891"/>
            <a:chExt cx="2683666" cy="2166571"/>
          </a:xfrm>
        </p:grpSpPr>
        <p:pic>
          <p:nvPicPr>
            <p:cNvPr id="77" name="Picture 76">
              <a:extLst>
                <a:ext uri="{FF2B5EF4-FFF2-40B4-BE49-F238E27FC236}">
                  <a16:creationId xmlns:a16="http://schemas.microsoft.com/office/drawing/2014/main" id="{DFE9EA30-CA2B-0C36-B1C1-866DA335DE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582930" y="4255891"/>
              <a:ext cx="2575489" cy="1737360"/>
            </a:xfrm>
            <a:prstGeom prst="rect">
              <a:avLst/>
            </a:prstGeom>
          </p:spPr>
        </p:pic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304433CB-A007-8F31-D202-B7422AE57F07}"/>
                </a:ext>
              </a:extLst>
            </p:cNvPr>
            <p:cNvSpPr/>
            <p:nvPr/>
          </p:nvSpPr>
          <p:spPr>
            <a:xfrm>
              <a:off x="4091549" y="6043091"/>
              <a:ext cx="1902255" cy="7227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893CED87-F105-F78B-9458-7068F445C1BB}"/>
                </a:ext>
              </a:extLst>
            </p:cNvPr>
            <p:cNvSpPr/>
            <p:nvPr/>
          </p:nvSpPr>
          <p:spPr>
            <a:xfrm>
              <a:off x="4088694" y="6165371"/>
              <a:ext cx="1902255" cy="56393"/>
            </a:xfrm>
            <a:prstGeom prst="rect">
              <a:avLst/>
            </a:prstGeom>
            <a:solidFill>
              <a:srgbClr val="009193"/>
            </a:solidFill>
            <a:ln>
              <a:solidFill>
                <a:srgbClr val="009193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9C638DB8-B14F-C350-5017-DE940316239A}"/>
                </a:ext>
              </a:extLst>
            </p:cNvPr>
            <p:cNvSpPr/>
            <p:nvPr/>
          </p:nvSpPr>
          <p:spPr>
            <a:xfrm>
              <a:off x="4095090" y="6281574"/>
              <a:ext cx="1060274" cy="64617"/>
            </a:xfrm>
            <a:prstGeom prst="rect">
              <a:avLst/>
            </a:prstGeom>
            <a:solidFill>
              <a:srgbClr val="FF7F7F"/>
            </a:solidFill>
            <a:ln>
              <a:solidFill>
                <a:srgbClr val="FF7F7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CD792FF-1177-A8BB-3A6C-1778B7D27786}"/>
                </a:ext>
              </a:extLst>
            </p:cNvPr>
            <p:cNvSpPr txBox="1"/>
            <p:nvPr/>
          </p:nvSpPr>
          <p:spPr>
            <a:xfrm>
              <a:off x="5933928" y="5977701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2CE52D15-5C58-D638-81C0-38ECBAEB195F}"/>
                </a:ext>
              </a:extLst>
            </p:cNvPr>
            <p:cNvSpPr txBox="1"/>
            <p:nvPr/>
          </p:nvSpPr>
          <p:spPr>
            <a:xfrm>
              <a:off x="5933928" y="613390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E5753673-25D2-0CC6-9288-5C1E833F2042}"/>
                </a:ext>
              </a:extLst>
            </p:cNvPr>
            <p:cNvSpPr txBox="1"/>
            <p:nvPr/>
          </p:nvSpPr>
          <p:spPr>
            <a:xfrm>
              <a:off x="5090228" y="6207018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C1EE4C65-AACF-0F1E-2335-34219CED4052}"/>
                </a:ext>
              </a:extLst>
            </p:cNvPr>
            <p:cNvSpPr txBox="1"/>
            <p:nvPr/>
          </p:nvSpPr>
          <p:spPr>
            <a:xfrm>
              <a:off x="3655441" y="5959200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E1A43C2E-5D28-B656-7691-49DBE9B2607A}"/>
                </a:ext>
              </a:extLst>
            </p:cNvPr>
            <p:cNvSpPr txBox="1"/>
            <p:nvPr/>
          </p:nvSpPr>
          <p:spPr>
            <a:xfrm>
              <a:off x="3552724" y="6078947"/>
              <a:ext cx="6094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5 mg/kg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BFE7F70-C803-5EFF-DDBE-8694EA35AF44}"/>
                </a:ext>
              </a:extLst>
            </p:cNvPr>
            <p:cNvSpPr txBox="1"/>
            <p:nvPr/>
          </p:nvSpPr>
          <p:spPr>
            <a:xfrm>
              <a:off x="3550344" y="6203263"/>
              <a:ext cx="6094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0 mg/kg</a:t>
              </a:r>
            </a:p>
          </p:txBody>
        </p:sp>
      </p:grpSp>
      <p:sp>
        <p:nvSpPr>
          <p:cNvPr id="116" name="TextBox 115">
            <a:extLst>
              <a:ext uri="{FF2B5EF4-FFF2-40B4-BE49-F238E27FC236}">
                <a16:creationId xmlns:a16="http://schemas.microsoft.com/office/drawing/2014/main" id="{A46D6230-83DC-A9C8-E08B-B0E36973C32A}"/>
              </a:ext>
            </a:extLst>
          </p:cNvPr>
          <p:cNvSpPr txBox="1"/>
          <p:nvPr/>
        </p:nvSpPr>
        <p:spPr>
          <a:xfrm>
            <a:off x="632551" y="6015121"/>
            <a:ext cx="7572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D4BE6E60-07E8-9441-FF99-7E27A7EE532C}"/>
              </a:ext>
            </a:extLst>
          </p:cNvPr>
          <p:cNvGrpSpPr/>
          <p:nvPr/>
        </p:nvGrpSpPr>
        <p:grpSpPr>
          <a:xfrm>
            <a:off x="611068" y="4415748"/>
            <a:ext cx="5612724" cy="1372645"/>
            <a:chOff x="525607" y="6771698"/>
            <a:chExt cx="5612724" cy="1372645"/>
          </a:xfrm>
        </p:grpSpPr>
        <p:graphicFrame>
          <p:nvGraphicFramePr>
            <p:cNvPr id="118" name="Chart 117">
              <a:extLst>
                <a:ext uri="{FF2B5EF4-FFF2-40B4-BE49-F238E27FC236}">
                  <a16:creationId xmlns:a16="http://schemas.microsoft.com/office/drawing/2014/main" id="{DD716B51-C010-943F-9D4A-F94D3DF2648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892513" y="6887202"/>
            <a:ext cx="1735282" cy="112793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119" name="Chart 118">
              <a:extLst>
                <a:ext uri="{FF2B5EF4-FFF2-40B4-BE49-F238E27FC236}">
                  <a16:creationId xmlns:a16="http://schemas.microsoft.com/office/drawing/2014/main" id="{450B6F75-7FF2-300D-A44E-1560B975AC14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491418" y="6882449"/>
            <a:ext cx="1735282" cy="114331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aphicFrame>
          <p:nvGraphicFramePr>
            <p:cNvPr id="128" name="Chart 127">
              <a:extLst>
                <a:ext uri="{FF2B5EF4-FFF2-40B4-BE49-F238E27FC236}">
                  <a16:creationId xmlns:a16="http://schemas.microsoft.com/office/drawing/2014/main" id="{5C21F0F1-2EAD-4F29-0008-A9CD9C0F48B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094991" y="6883913"/>
            <a:ext cx="1735282" cy="11418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8B1C22C0-4449-2696-577C-D3CE15AC1D0C}"/>
                </a:ext>
              </a:extLst>
            </p:cNvPr>
            <p:cNvSpPr txBox="1"/>
            <p:nvPr/>
          </p:nvSpPr>
          <p:spPr>
            <a:xfrm rot="16200000">
              <a:off x="224563" y="7212294"/>
              <a:ext cx="100219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umor volume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mm</a:t>
              </a:r>
              <a:r>
                <a:rPr lang="en-US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6B25F375-9406-ABCB-AAB9-D89994EDACDC}"/>
                </a:ext>
              </a:extLst>
            </p:cNvPr>
            <p:cNvSpPr txBox="1"/>
            <p:nvPr/>
          </p:nvSpPr>
          <p:spPr>
            <a:xfrm>
              <a:off x="3277176" y="791351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679B36D9-2FA7-B8EC-F798-406BCBED666F}"/>
                </a:ext>
              </a:extLst>
            </p:cNvPr>
            <p:cNvSpPr txBox="1"/>
            <p:nvPr/>
          </p:nvSpPr>
          <p:spPr>
            <a:xfrm>
              <a:off x="1546483" y="6771698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B3AA076D-3EFD-C09B-6CAD-42D4A712929B}"/>
                </a:ext>
              </a:extLst>
            </p:cNvPr>
            <p:cNvSpPr txBox="1"/>
            <p:nvPr/>
          </p:nvSpPr>
          <p:spPr>
            <a:xfrm>
              <a:off x="2853458" y="6775519"/>
              <a:ext cx="130035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LX-001 (25 mg/kg)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F9BADF6-468D-3DA7-D561-EF90FC7BB4C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4594091" y="6795835"/>
              <a:ext cx="15442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CLX-001 (50 mg/kg)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C4A41CF6-F51B-3210-AA07-912CBC232478}"/>
                </a:ext>
              </a:extLst>
            </p:cNvPr>
            <p:cNvSpPr txBox="1"/>
            <p:nvPr/>
          </p:nvSpPr>
          <p:spPr>
            <a:xfrm>
              <a:off x="1654189" y="7883327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F70ED105-52A3-F1DF-EB68-19BF1EE8A179}"/>
                </a:ext>
              </a:extLst>
            </p:cNvPr>
            <p:cNvSpPr txBox="1"/>
            <p:nvPr/>
          </p:nvSpPr>
          <p:spPr>
            <a:xfrm>
              <a:off x="4876068" y="7913511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</a:p>
          </p:txBody>
        </p:sp>
        <p:sp>
          <p:nvSpPr>
            <p:cNvPr id="136" name="Triangle 135">
              <a:extLst>
                <a:ext uri="{FF2B5EF4-FFF2-40B4-BE49-F238E27FC236}">
                  <a16:creationId xmlns:a16="http://schemas.microsoft.com/office/drawing/2014/main" id="{B17777DF-033A-378C-6CF6-25A51178A8DD}"/>
                </a:ext>
              </a:extLst>
            </p:cNvPr>
            <p:cNvSpPr/>
            <p:nvPr/>
          </p:nvSpPr>
          <p:spPr>
            <a:xfrm flipV="1">
              <a:off x="4595019" y="7360810"/>
              <a:ext cx="45719" cy="103077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" name="Triangle 136">
              <a:extLst>
                <a:ext uri="{FF2B5EF4-FFF2-40B4-BE49-F238E27FC236}">
                  <a16:creationId xmlns:a16="http://schemas.microsoft.com/office/drawing/2014/main" id="{79F74039-E089-FEA2-5315-2B1F92546EE2}"/>
                </a:ext>
              </a:extLst>
            </p:cNvPr>
            <p:cNvSpPr/>
            <p:nvPr/>
          </p:nvSpPr>
          <p:spPr>
            <a:xfrm flipV="1">
              <a:off x="5067369" y="7360810"/>
              <a:ext cx="45719" cy="103077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8" name="Triangle 137">
              <a:extLst>
                <a:ext uri="{FF2B5EF4-FFF2-40B4-BE49-F238E27FC236}">
                  <a16:creationId xmlns:a16="http://schemas.microsoft.com/office/drawing/2014/main" id="{7C5C9E19-FB48-66D9-216A-979DA9DC7954}"/>
                </a:ext>
              </a:extLst>
            </p:cNvPr>
            <p:cNvSpPr/>
            <p:nvPr/>
          </p:nvSpPr>
          <p:spPr>
            <a:xfrm flipV="1">
              <a:off x="5281530" y="7360810"/>
              <a:ext cx="45719" cy="103077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9" name="Triangle 138">
              <a:extLst>
                <a:ext uri="{FF2B5EF4-FFF2-40B4-BE49-F238E27FC236}">
                  <a16:creationId xmlns:a16="http://schemas.microsoft.com/office/drawing/2014/main" id="{C231A322-A860-024F-C3D3-ADD8FF4DD7FF}"/>
                </a:ext>
              </a:extLst>
            </p:cNvPr>
            <p:cNvSpPr/>
            <p:nvPr/>
          </p:nvSpPr>
          <p:spPr>
            <a:xfrm flipV="1">
              <a:off x="5155363" y="7360810"/>
              <a:ext cx="45719" cy="103077"/>
            </a:xfrm>
            <a:prstGeom prst="triangle">
              <a:avLst/>
            </a:prstGeom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0" name="TextBox 139">
            <a:extLst>
              <a:ext uri="{FF2B5EF4-FFF2-40B4-BE49-F238E27FC236}">
                <a16:creationId xmlns:a16="http://schemas.microsoft.com/office/drawing/2014/main" id="{CE12AB63-7590-14E2-108C-0D6C1FE6C1EB}"/>
              </a:ext>
            </a:extLst>
          </p:cNvPr>
          <p:cNvSpPr txBox="1"/>
          <p:nvPr/>
        </p:nvSpPr>
        <p:spPr>
          <a:xfrm>
            <a:off x="572708" y="4195047"/>
            <a:ext cx="698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53450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EBD7A5A-AED4-6BBA-EA18-76986A4044FE}"/>
              </a:ext>
            </a:extLst>
          </p:cNvPr>
          <p:cNvSpPr txBox="1"/>
          <p:nvPr/>
        </p:nvSpPr>
        <p:spPr>
          <a:xfrm>
            <a:off x="365919" y="571500"/>
            <a:ext cx="5943600" cy="42130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2: Genetic targeting of NMT1 decreases the viability of (KL/K)</a:t>
            </a:r>
            <a:r>
              <a:rPr lang="en-US" sz="1200" b="1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UT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lung carcinoma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(A) 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lony assay of (KL/K)</a:t>
            </a:r>
            <a:r>
              <a:rPr lang="en-US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1792 cells expressing Tet-inducible non-targeting or NMT1 #10 shRNAs in the presence or absence of Doxycycline (Dox). Bottom, graphs showing quantification (percent covered area). (**) p=0.0028, ns=not significant (Student’s t-test). (B) Colony assay using (KL/K)</a:t>
            </a:r>
            <a:r>
              <a:rPr lang="en-US" sz="1200" kern="0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UT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CC44 cells stably expressing Tet-inducible control or NMT1 #10 shRNAs growth in the presence or absence of Doxycycline (Dox). Representative images from wells are shown. Bottom, graphs showing quantification (percent covered area). (**) p=0.0019, ns=not significant (Student’s t-test).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C) H460 xenograft tumor volume (mm</a:t>
            </a:r>
            <a:r>
              <a:rPr lang="en-US" sz="1200" kern="100" baseline="30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3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from mice treated with vehicle control or PCLX-001 (25 and 50 mg/kg). Control, n=9; 25 mg/kg n=10; 50 mg/kg, n=10. Arrowheads, day of study at which an animal was lost in the 50 mg/kg group  (1, 9, 10 and 14). (D) Relative change in body weight of mice treated with vehicle control or PCLX-001 (25 and 50 mg/kg). Length of treatment was indicated by the colored bars (18 days for 25 mg/kg group, and 10 days for 50 mg/kg group). </a:t>
            </a:r>
          </a:p>
        </p:txBody>
      </p:sp>
    </p:spTree>
    <p:extLst>
      <p:ext uri="{BB962C8B-B14F-4D97-AF65-F5344CB8AC3E}">
        <p14:creationId xmlns:p14="http://schemas.microsoft.com/office/powerpoint/2010/main" val="2594360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07</TotalTime>
  <Words>349</Words>
  <Application>Microsoft Macintosh PowerPoint</Application>
  <PresentationFormat>Custom</PresentationFormat>
  <Paragraphs>4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z, Begona</dc:creator>
  <cp:lastModifiedBy>Diaz, Begona</cp:lastModifiedBy>
  <cp:revision>141</cp:revision>
  <dcterms:created xsi:type="dcterms:W3CDTF">2023-03-19T23:47:27Z</dcterms:created>
  <dcterms:modified xsi:type="dcterms:W3CDTF">2024-06-18T17:54:20Z</dcterms:modified>
</cp:coreProperties>
</file>